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4"/>
    <p:restoredTop sz="97164"/>
  </p:normalViewPr>
  <p:slideViewPr>
    <p:cSldViewPr snapToGrid="0" snapToObjects="1">
      <p:cViewPr varScale="1">
        <p:scale>
          <a:sx n="64" d="100"/>
          <a:sy n="64" d="100"/>
        </p:scale>
        <p:origin x="261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219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623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247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17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805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35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690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401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07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30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4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049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8975D9-D98F-7E49-A83E-BC7EF1E08BB3}"/>
              </a:ext>
            </a:extLst>
          </p:cNvPr>
          <p:cNvSpPr txBox="1"/>
          <p:nvPr/>
        </p:nvSpPr>
        <p:spPr>
          <a:xfrm>
            <a:off x="812800" y="751897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S-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B379F0-8D4B-594A-B03A-3BDE6E6848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18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</a:extLst>
          </a:blip>
          <a:srcRect l="4493" t="5337" r="11572" b="7144"/>
          <a:stretch/>
        </p:blipFill>
        <p:spPr>
          <a:xfrm>
            <a:off x="1059021" y="1158785"/>
            <a:ext cx="5030482" cy="309559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E213919-2227-9642-A283-C9545A963CF6}"/>
              </a:ext>
            </a:extLst>
          </p:cNvPr>
          <p:cNvSpPr txBox="1"/>
          <p:nvPr/>
        </p:nvSpPr>
        <p:spPr>
          <a:xfrm>
            <a:off x="1994059" y="4254378"/>
            <a:ext cx="23070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otal time under vasopressors (Hours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908BF4B-9060-394E-9EBE-1EA827C69B4D}"/>
              </a:ext>
            </a:extLst>
          </p:cNvPr>
          <p:cNvSpPr txBox="1"/>
          <p:nvPr/>
        </p:nvSpPr>
        <p:spPr>
          <a:xfrm rot="16200000">
            <a:off x="-220816" y="2519405"/>
            <a:ext cx="23134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ime to first dose of Midodrine (Hours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4DFEE37-02C8-1F49-995E-89767CBB2A0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05" t="5305" r="9726" b="6921"/>
          <a:stretch/>
        </p:blipFill>
        <p:spPr>
          <a:xfrm>
            <a:off x="1145060" y="4677928"/>
            <a:ext cx="5029318" cy="306249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3FC2946-A814-1E4B-A952-EFDB38A7A0D9}"/>
              </a:ext>
            </a:extLst>
          </p:cNvPr>
          <p:cNvSpPr txBox="1"/>
          <p:nvPr/>
        </p:nvSpPr>
        <p:spPr>
          <a:xfrm>
            <a:off x="1503540" y="7740422"/>
            <a:ext cx="35573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ime between Midodrine and vasopressors cessation (Hours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4664F9F-B3FE-A446-8E6C-87776F644591}"/>
              </a:ext>
            </a:extLst>
          </p:cNvPr>
          <p:cNvSpPr txBox="1"/>
          <p:nvPr/>
        </p:nvSpPr>
        <p:spPr>
          <a:xfrm rot="16200000">
            <a:off x="-220816" y="5881758"/>
            <a:ext cx="23134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ime to first dose of Midodrine (Hours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7064DB-2069-EA44-B7E3-3721A1645B7C}"/>
              </a:ext>
            </a:extLst>
          </p:cNvPr>
          <p:cNvSpPr txBox="1"/>
          <p:nvPr/>
        </p:nvSpPr>
        <p:spPr>
          <a:xfrm>
            <a:off x="1203291" y="8229600"/>
            <a:ext cx="488621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the time to the first dose of Midodrine and the total time under vasopressors (R=0.76, p&lt;0.001, Pearson) or between the time to the first dose of Midodrine and vasopressors weaning (R= 0.07, p=0.96; Pearson)</a:t>
            </a:r>
          </a:p>
        </p:txBody>
      </p:sp>
    </p:spTree>
    <p:extLst>
      <p:ext uri="{BB962C8B-B14F-4D97-AF65-F5344CB8AC3E}">
        <p14:creationId xmlns:p14="http://schemas.microsoft.com/office/powerpoint/2010/main" val="1721917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5</TotalTime>
  <Words>87</Words>
  <Application>Microsoft Office PowerPoint</Application>
  <PresentationFormat>Format US (216 x 279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charbonney echarbonney</dc:creator>
  <cp:lastModifiedBy>Jan-Alexis Tremblay</cp:lastModifiedBy>
  <cp:revision>9</cp:revision>
  <dcterms:created xsi:type="dcterms:W3CDTF">2020-07-31T00:16:02Z</dcterms:created>
  <dcterms:modified xsi:type="dcterms:W3CDTF">2020-07-31T20:19:01Z</dcterms:modified>
</cp:coreProperties>
</file>